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84" y="-192"/>
      </p:cViewPr>
      <p:guideLst>
        <p:guide orient="horz" pos="2160"/>
        <p:guide pos="2880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870-54\Projets%20bis\Projets%20AMM\Stage%20Clara%20Berl&#233;\ESTBB\R&#233;sultats\R&#233;sultats%20Dose%20r&#233;ponse%20final\R&#233;sultat%20Dose%20r&#233;ponse%20-%209.7.13.xls" TargetMode="External"/><Relationship Id="rId2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8306248952923"/>
          <c:y val="0.0586906636670416"/>
          <c:w val="0.700084578402555"/>
          <c:h val="0.7594222198735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2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euil3!$E$33:$E$38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.761083230203894</c:v>
                  </c:pt>
                  <c:pt idx="2">
                    <c:v>8.09973937563331</c:v>
                  </c:pt>
                  <c:pt idx="3">
                    <c:v>4.972378864450376</c:v>
                  </c:pt>
                  <c:pt idx="4">
                    <c:v>5.213303754725403</c:v>
                  </c:pt>
                  <c:pt idx="5">
                    <c:v>0.0963699561100077</c:v>
                  </c:pt>
                </c:numCache>
              </c:numRef>
            </c:plus>
            <c:spPr>
              <a:solidFill>
                <a:schemeClr val="tx2"/>
              </a:solidFill>
              <a:ln>
                <a:solidFill>
                  <a:sysClr val="windowText" lastClr="000000"/>
                </a:solidFill>
              </a:ln>
            </c:spPr>
          </c:errBars>
          <c:cat>
            <c:strRef>
              <c:f>Aniso!$H$31:$H$36</c:f>
              <c:strCache>
                <c:ptCount val="6"/>
                <c:pt idx="0">
                  <c:v>BSA</c:v>
                </c:pt>
                <c:pt idx="1">
                  <c:v>BSA + Ao 100 nM</c:v>
                </c:pt>
                <c:pt idx="2">
                  <c:v>BSA + Ao 200 nM</c:v>
                </c:pt>
                <c:pt idx="3">
                  <c:v>BSA + Ao 500 nM</c:v>
                </c:pt>
                <c:pt idx="4">
                  <c:v>BSA + Ao 1 uM</c:v>
                </c:pt>
                <c:pt idx="5">
                  <c:v>BSA + Ao 2 uM</c:v>
                </c:pt>
              </c:strCache>
            </c:strRef>
          </c:cat>
          <c:val>
            <c:numRef>
              <c:f>Aniso!$I$31:$I$36</c:f>
              <c:numCache>
                <c:formatCode>0\.0</c:formatCode>
                <c:ptCount val="6"/>
                <c:pt idx="0" formatCode="General">
                  <c:v>100.0</c:v>
                </c:pt>
                <c:pt idx="1">
                  <c:v>102.4905477886222</c:v>
                </c:pt>
                <c:pt idx="2">
                  <c:v>83.74219643014157</c:v>
                </c:pt>
                <c:pt idx="3">
                  <c:v>78.50171458718016</c:v>
                </c:pt>
                <c:pt idx="4">
                  <c:v>46.087224127319</c:v>
                </c:pt>
                <c:pt idx="5">
                  <c:v>45.559658841114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9"/>
        <c:axId val="2105578360"/>
        <c:axId val="2105581608"/>
      </c:barChart>
      <c:catAx>
        <c:axId val="2105578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fr-FR"/>
          </a:p>
        </c:txPr>
        <c:crossAx val="2105581608"/>
        <c:crosses val="autoZero"/>
        <c:auto val="1"/>
        <c:lblAlgn val="ctr"/>
        <c:lblOffset val="100"/>
        <c:noMultiLvlLbl val="0"/>
      </c:catAx>
      <c:valAx>
        <c:axId val="21055816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fr-FR" sz="1200" b="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n</a:t>
                </a:r>
                <a:r>
                  <a:rPr lang="fr-FR" sz="12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% of control)</a:t>
                </a:r>
                <a:endParaRPr lang="fr-FR" sz="12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21055783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4087</cdr:x>
      <cdr:y>0.85606</cdr:y>
    </cdr:from>
    <cdr:to>
      <cdr:x>0.97115</cdr:x>
      <cdr:y>0.9697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161925" y="2152650"/>
          <a:ext cx="3686175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</cdr:x>
      <cdr:y>0.84286</cdr:y>
    </cdr:from>
    <cdr:to>
      <cdr:x>0.9806</cdr:x>
      <cdr:y>1</cdr:y>
    </cdr:to>
    <cdr:sp macro="" textlink="">
      <cdr:nvSpPr>
        <cdr:cNvPr id="3" name="ZoneTexte 2"/>
        <cdr:cNvSpPr txBox="1"/>
      </cdr:nvSpPr>
      <cdr:spPr>
        <a:xfrm xmlns:a="http://schemas.openxmlformats.org/drawingml/2006/main">
          <a:off x="-36512" y="2449611"/>
          <a:ext cx="4944332" cy="456697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fr-FR" sz="1200" b="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 </a:t>
          </a:r>
          <a:r>
            <a:rPr lang="fr-FR" sz="1200" b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Anisomycin</a:t>
          </a:r>
          <a:r>
            <a:rPr lang="fr-FR" sz="1200" b="0" baseline="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r-FR" sz="1200" b="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(</a:t>
          </a:r>
          <a:r>
            <a:rPr lang="fr-FR" sz="1200" b="0" i="0" baseline="0" dirty="0" smtClean="0"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µM)</a:t>
          </a:r>
          <a:r>
            <a:rPr lang="fr-FR" sz="1200" b="0" i="0" dirty="0" smtClean="0"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r-FR" sz="1200" b="0" baseline="0" dirty="0" smtClean="0"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        </a:t>
          </a:r>
          <a:r>
            <a:rPr lang="fr-FR" sz="1200" b="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0      </a:t>
          </a:r>
          <a:r>
            <a:rPr lang="fr-FR" sz="1200" b="0" baseline="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     0.1          0.2           0.5            </a:t>
          </a:r>
          <a:r>
            <a:rPr lang="fr-FR" sz="1200" b="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1  </a:t>
          </a:r>
          <a:r>
            <a:rPr lang="fr-FR" sz="1200" b="0" baseline="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          </a:t>
          </a:r>
          <a:r>
            <a:rPr lang="fr-FR" sz="1200" b="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2      </a:t>
          </a:r>
          <a:r>
            <a:rPr lang="fr-FR" sz="1200" b="0" dirty="0"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fr-FR" sz="1200" b="0" dirty="0" smtClean="0"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endParaRPr lang="fr-FR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664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822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859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618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70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932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707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349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656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272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004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CEAC22-E130-4601-B5FC-A9BF8363591C}" type="datetimeFigureOut">
              <a:rPr lang="en-US" smtClean="0"/>
              <a:t>14/12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C6FF6D-612C-48E5-8524-F762F9DD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695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143508" y="219998"/>
            <a:ext cx="2376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Fig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Grouper 19"/>
          <p:cNvGrpSpPr/>
          <p:nvPr/>
        </p:nvGrpSpPr>
        <p:grpSpPr>
          <a:xfrm>
            <a:off x="1547663" y="620687"/>
            <a:ext cx="5769583" cy="4432260"/>
            <a:chOff x="1547663" y="620687"/>
            <a:chExt cx="5769583" cy="4432260"/>
          </a:xfrm>
        </p:grpSpPr>
        <p:grpSp>
          <p:nvGrpSpPr>
            <p:cNvPr id="2" name="Grouper 1"/>
            <p:cNvGrpSpPr/>
            <p:nvPr/>
          </p:nvGrpSpPr>
          <p:grpSpPr>
            <a:xfrm>
              <a:off x="1547663" y="620687"/>
              <a:ext cx="5769583" cy="4432260"/>
              <a:chOff x="1547887" y="1218597"/>
              <a:chExt cx="5634873" cy="4328773"/>
            </a:xfrm>
          </p:grpSpPr>
          <p:graphicFrame>
            <p:nvGraphicFramePr>
              <p:cNvPr id="4" name="Graphique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26393710"/>
                  </p:ext>
                </p:extLst>
              </p:nvPr>
            </p:nvGraphicFramePr>
            <p:xfrm>
              <a:off x="1841522" y="2708920"/>
              <a:ext cx="4924425" cy="28384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27" name="Groupe 26"/>
              <p:cNvGrpSpPr/>
              <p:nvPr/>
            </p:nvGrpSpPr>
            <p:grpSpPr>
              <a:xfrm>
                <a:off x="1547887" y="1268760"/>
                <a:ext cx="5634873" cy="1153666"/>
                <a:chOff x="1547887" y="1268760"/>
                <a:chExt cx="5634873" cy="1153666"/>
              </a:xfrm>
            </p:grpSpPr>
            <p:pic>
              <p:nvPicPr>
                <p:cNvPr id="6" name="Image 5"/>
                <p:cNvPicPr/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703" t="34836" r="22788" b="51378"/>
                <a:stretch/>
              </p:blipFill>
              <p:spPr bwMode="auto">
                <a:xfrm>
                  <a:off x="2339752" y="1412776"/>
                  <a:ext cx="4509851" cy="10096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sp>
              <p:nvSpPr>
                <p:cNvPr id="7" name="Rectangle 6"/>
                <p:cNvSpPr/>
                <p:nvPr/>
              </p:nvSpPr>
              <p:spPr>
                <a:xfrm>
                  <a:off x="2627784" y="1268760"/>
                  <a:ext cx="4104456" cy="7200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Rectangle 7"/>
                <p:cNvSpPr/>
                <p:nvPr/>
              </p:nvSpPr>
              <p:spPr>
                <a:xfrm>
                  <a:off x="2267744" y="2060848"/>
                  <a:ext cx="504056" cy="1440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" name="ZoneTexte 8"/>
                <p:cNvSpPr txBox="1"/>
                <p:nvPr/>
              </p:nvSpPr>
              <p:spPr>
                <a:xfrm>
                  <a:off x="2370232" y="1973883"/>
                  <a:ext cx="648072" cy="270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tin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" name="Connecteur droit 2"/>
                <p:cNvCxnSpPr/>
                <p:nvPr/>
              </p:nvCxnSpPr>
              <p:spPr>
                <a:xfrm>
                  <a:off x="3201086" y="1923683"/>
                  <a:ext cx="468052" cy="76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Connecteur droit 10"/>
                <p:cNvCxnSpPr/>
                <p:nvPr/>
              </p:nvCxnSpPr>
              <p:spPr>
                <a:xfrm>
                  <a:off x="3836680" y="1923683"/>
                  <a:ext cx="468052" cy="76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Connecteur droit 11"/>
                <p:cNvCxnSpPr/>
                <p:nvPr/>
              </p:nvCxnSpPr>
              <p:spPr>
                <a:xfrm>
                  <a:off x="4486848" y="1923683"/>
                  <a:ext cx="468052" cy="76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Connecteur droit 12"/>
                <p:cNvCxnSpPr/>
                <p:nvPr/>
              </p:nvCxnSpPr>
              <p:spPr>
                <a:xfrm>
                  <a:off x="5112060" y="1923683"/>
                  <a:ext cx="468052" cy="76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Connecteur droit 13"/>
                <p:cNvCxnSpPr/>
                <p:nvPr/>
              </p:nvCxnSpPr>
              <p:spPr>
                <a:xfrm>
                  <a:off x="5832140" y="1923683"/>
                  <a:ext cx="468052" cy="76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ZoneTexte 14"/>
                <p:cNvSpPr txBox="1"/>
                <p:nvPr/>
              </p:nvSpPr>
              <p:spPr>
                <a:xfrm>
                  <a:off x="1547887" y="1710885"/>
                  <a:ext cx="1434636" cy="270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nisomycin (µM)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7" name="Connecteur droit 16"/>
                <p:cNvCxnSpPr/>
                <p:nvPr/>
              </p:nvCxnSpPr>
              <p:spPr>
                <a:xfrm>
                  <a:off x="2771800" y="1924452"/>
                  <a:ext cx="36004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" name="ZoneTexte 17"/>
                <p:cNvSpPr txBox="1"/>
                <p:nvPr/>
              </p:nvSpPr>
              <p:spPr>
                <a:xfrm>
                  <a:off x="2844278" y="1689083"/>
                  <a:ext cx="375280" cy="270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ZoneTexte 18"/>
                <p:cNvSpPr txBox="1"/>
                <p:nvPr/>
              </p:nvSpPr>
              <p:spPr>
                <a:xfrm>
                  <a:off x="3260616" y="1689083"/>
                  <a:ext cx="375280" cy="270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ZoneTexte 20"/>
                <p:cNvSpPr txBox="1"/>
                <p:nvPr/>
              </p:nvSpPr>
              <p:spPr>
                <a:xfrm>
                  <a:off x="3910980" y="1689083"/>
                  <a:ext cx="375280" cy="270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2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ZoneTexte 21"/>
                <p:cNvSpPr txBox="1"/>
                <p:nvPr/>
              </p:nvSpPr>
              <p:spPr>
                <a:xfrm>
                  <a:off x="4556760" y="1689083"/>
                  <a:ext cx="375280" cy="270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5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ZoneTexte 22"/>
                <p:cNvSpPr txBox="1"/>
                <p:nvPr/>
              </p:nvSpPr>
              <p:spPr>
                <a:xfrm>
                  <a:off x="5232540" y="1689083"/>
                  <a:ext cx="375280" cy="270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ZoneTexte 23"/>
                <p:cNvSpPr txBox="1"/>
                <p:nvPr/>
              </p:nvSpPr>
              <p:spPr>
                <a:xfrm>
                  <a:off x="5940152" y="1689083"/>
                  <a:ext cx="375280" cy="270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Rectangle 24"/>
                <p:cNvSpPr/>
                <p:nvPr/>
              </p:nvSpPr>
              <p:spPr>
                <a:xfrm>
                  <a:off x="6399908" y="1825798"/>
                  <a:ext cx="576064" cy="5966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6" name="ZoneTexte 25"/>
                <p:cNvSpPr txBox="1"/>
                <p:nvPr/>
              </p:nvSpPr>
              <p:spPr>
                <a:xfrm>
                  <a:off x="6349134" y="2051612"/>
                  <a:ext cx="833626" cy="270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3 kDa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8" name="ZoneTexte 27"/>
              <p:cNvSpPr txBox="1"/>
              <p:nvPr/>
            </p:nvSpPr>
            <p:spPr>
              <a:xfrm>
                <a:off x="1557246" y="1218597"/>
                <a:ext cx="50405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b="1" dirty="0" smtClean="0"/>
                  <a:t>a</a:t>
                </a:r>
                <a:endParaRPr lang="en-US" b="1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1564256" y="2627620"/>
                <a:ext cx="50405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b="1" dirty="0" smtClean="0"/>
                  <a:t>b</a:t>
                </a:r>
                <a:endParaRPr lang="en-US" b="1" dirty="0"/>
              </a:p>
            </p:txBody>
          </p:sp>
        </p:grpSp>
        <p:sp>
          <p:nvSpPr>
            <p:cNvPr id="16" name="ZoneTexte 15"/>
            <p:cNvSpPr txBox="1"/>
            <p:nvPr/>
          </p:nvSpPr>
          <p:spPr>
            <a:xfrm>
              <a:off x="5640966" y="3314340"/>
              <a:ext cx="690855" cy="3781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**</a:t>
              </a:r>
              <a:endParaRPr lang="en-US" dirty="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6238828" y="3324225"/>
              <a:ext cx="690855" cy="3781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**</a:t>
              </a:r>
              <a:endParaRPr lang="en-US" dirty="0"/>
            </a:p>
          </p:txBody>
        </p:sp>
        <p:cxnSp>
          <p:nvCxnSpPr>
            <p:cNvPr id="31" name="Connecteur droit 30"/>
            <p:cNvCxnSpPr/>
            <p:nvPr/>
          </p:nvCxnSpPr>
          <p:spPr>
            <a:xfrm flipV="1">
              <a:off x="6444184" y="3589370"/>
              <a:ext cx="0" cy="9215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cteur droit 33"/>
            <p:cNvCxnSpPr/>
            <p:nvPr/>
          </p:nvCxnSpPr>
          <p:spPr>
            <a:xfrm>
              <a:off x="6410285" y="3502835"/>
              <a:ext cx="7372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0838081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</TotalTime>
  <Words>39</Words>
  <Application>Microsoft Macintosh PowerPoint</Application>
  <PresentationFormat>Présentation à l'écran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meo Cassel</dc:creator>
  <cp:lastModifiedBy>anne-marie madec</cp:lastModifiedBy>
  <cp:revision>24</cp:revision>
  <dcterms:created xsi:type="dcterms:W3CDTF">2014-09-05T14:54:16Z</dcterms:created>
  <dcterms:modified xsi:type="dcterms:W3CDTF">2015-12-14T13:20:40Z</dcterms:modified>
</cp:coreProperties>
</file>